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BCF1FDA-C6D0-427D-8CEC-3529626B076C}" v="2" dt="2023-04-14T10:57:08.7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80" y="12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엄 경현" userId="006d52b91ace3e0e" providerId="LiveId" clId="{ABCF1FDA-C6D0-427D-8CEC-3529626B076C}"/>
    <pc:docChg chg="custSel modSld modMainMaster">
      <pc:chgData name="엄 경현" userId="006d52b91ace3e0e" providerId="LiveId" clId="{ABCF1FDA-C6D0-427D-8CEC-3529626B076C}" dt="2023-04-14T10:57:08.790" v="4"/>
      <pc:docMkLst>
        <pc:docMk/>
      </pc:docMkLst>
      <pc:sldChg chg="addSp delSp modSp mod">
        <pc:chgData name="엄 경현" userId="006d52b91ace3e0e" providerId="LiveId" clId="{ABCF1FDA-C6D0-427D-8CEC-3529626B076C}" dt="2023-04-14T10:57:08.790" v="4"/>
        <pc:sldMkLst>
          <pc:docMk/>
          <pc:sldMk cId="3600864397" sldId="280"/>
        </pc:sldMkLst>
        <pc:spChg chg="add mod">
          <ac:chgData name="엄 경현" userId="006d52b91ace3e0e" providerId="LiveId" clId="{ABCF1FDA-C6D0-427D-8CEC-3529626B076C}" dt="2023-04-14T10:57:08.790" v="4"/>
          <ac:spMkLst>
            <pc:docMk/>
            <pc:sldMk cId="3600864397" sldId="280"/>
            <ac:spMk id="4" creationId="{72859C1B-85F2-6FB3-D888-8851A7C9DEB5}"/>
          </ac:spMkLst>
        </pc:spChg>
        <pc:spChg chg="del mod">
          <ac:chgData name="엄 경현" userId="006d52b91ace3e0e" providerId="LiveId" clId="{ABCF1FDA-C6D0-427D-8CEC-3529626B076C}" dt="2023-04-14T10:57:05.344" v="3" actId="478"/>
          <ac:spMkLst>
            <pc:docMk/>
            <pc:sldMk cId="3600864397" sldId="280"/>
            <ac:spMk id="5" creationId="{330B8FCB-4240-F410-597D-E4B9C9043115}"/>
          </ac:spMkLst>
        </pc:spChg>
        <pc:graphicFrameChg chg="del mod">
          <ac:chgData name="엄 경현" userId="006d52b91ace3e0e" providerId="LiveId" clId="{ABCF1FDA-C6D0-427D-8CEC-3529626B076C}" dt="2023-04-14T10:57:05.344" v="3" actId="478"/>
          <ac:graphicFrameMkLst>
            <pc:docMk/>
            <pc:sldMk cId="3600864397" sldId="280"/>
            <ac:graphicFrameMk id="2" creationId="{65EEC2FD-D062-915C-0D80-D1509B5863A0}"/>
          </ac:graphicFrameMkLst>
        </pc:graphicFrameChg>
        <pc:graphicFrameChg chg="add mod">
          <ac:chgData name="엄 경현" userId="006d52b91ace3e0e" providerId="LiveId" clId="{ABCF1FDA-C6D0-427D-8CEC-3529626B076C}" dt="2023-04-14T10:57:08.790" v="4"/>
          <ac:graphicFrameMkLst>
            <pc:docMk/>
            <pc:sldMk cId="3600864397" sldId="280"/>
            <ac:graphicFrameMk id="3" creationId="{62AA0466-0146-7995-F1F2-EAC82CED3E8B}"/>
          </ac:graphicFrameMkLst>
        </pc:graphicFrameChg>
      </pc:sldChg>
      <pc:sldMasterChg chg="modSp modSldLayout">
        <pc:chgData name="엄 경현" userId="006d52b91ace3e0e" providerId="LiveId" clId="{ABCF1FDA-C6D0-427D-8CEC-3529626B076C}" dt="2023-04-14T10:56:58.829" v="0"/>
        <pc:sldMasterMkLst>
          <pc:docMk/>
          <pc:sldMasterMk cId="3484190589" sldId="2147483648"/>
        </pc:sldMasterMkLst>
        <pc:spChg chg="mod">
          <ac:chgData name="엄 경현" userId="006d52b91ace3e0e" providerId="LiveId" clId="{ABCF1FDA-C6D0-427D-8CEC-3529626B076C}" dt="2023-04-14T10:56:58.829" v="0"/>
          <ac:spMkLst>
            <pc:docMk/>
            <pc:sldMasterMk cId="3484190589" sldId="2147483648"/>
            <ac:spMk id="2" creationId="{74C0030F-C4D8-4AE6-E9C9-3D3A3CCAA611}"/>
          </ac:spMkLst>
        </pc:spChg>
        <pc:spChg chg="mod">
          <ac:chgData name="엄 경현" userId="006d52b91ace3e0e" providerId="LiveId" clId="{ABCF1FDA-C6D0-427D-8CEC-3529626B076C}" dt="2023-04-14T10:56:58.829" v="0"/>
          <ac:spMkLst>
            <pc:docMk/>
            <pc:sldMasterMk cId="3484190589" sldId="2147483648"/>
            <ac:spMk id="3" creationId="{0B15643A-F88E-959C-E931-44D86B76CFAD}"/>
          </ac:spMkLst>
        </pc:spChg>
        <pc:spChg chg="mod">
          <ac:chgData name="엄 경현" userId="006d52b91ace3e0e" providerId="LiveId" clId="{ABCF1FDA-C6D0-427D-8CEC-3529626B076C}" dt="2023-04-14T10:56:58.829" v="0"/>
          <ac:spMkLst>
            <pc:docMk/>
            <pc:sldMasterMk cId="3484190589" sldId="2147483648"/>
            <ac:spMk id="4" creationId="{D047EDC3-EA83-F1E9-12C7-BBB7FF374DE6}"/>
          </ac:spMkLst>
        </pc:spChg>
        <pc:spChg chg="mod">
          <ac:chgData name="엄 경현" userId="006d52b91ace3e0e" providerId="LiveId" clId="{ABCF1FDA-C6D0-427D-8CEC-3529626B076C}" dt="2023-04-14T10:56:58.829" v="0"/>
          <ac:spMkLst>
            <pc:docMk/>
            <pc:sldMasterMk cId="3484190589" sldId="2147483648"/>
            <ac:spMk id="5" creationId="{B7DEF150-FD75-C386-D7E8-7AC529486D12}"/>
          </ac:spMkLst>
        </pc:spChg>
        <pc:spChg chg="mod">
          <ac:chgData name="엄 경현" userId="006d52b91ace3e0e" providerId="LiveId" clId="{ABCF1FDA-C6D0-427D-8CEC-3529626B076C}" dt="2023-04-14T10:56:58.829" v="0"/>
          <ac:spMkLst>
            <pc:docMk/>
            <pc:sldMasterMk cId="3484190589" sldId="2147483648"/>
            <ac:spMk id="6" creationId="{A7B6CB00-6284-3FD4-3A65-F3A068F3CE8A}"/>
          </ac:spMkLst>
        </pc:spChg>
        <pc:sldLayoutChg chg="modSp">
          <pc:chgData name="엄 경현" userId="006d52b91ace3e0e" providerId="LiveId" clId="{ABCF1FDA-C6D0-427D-8CEC-3529626B076C}" dt="2023-04-14T10:56:58.829" v="0"/>
          <pc:sldLayoutMkLst>
            <pc:docMk/>
            <pc:sldMasterMk cId="3484190589" sldId="2147483648"/>
            <pc:sldLayoutMk cId="3896841876" sldId="2147483649"/>
          </pc:sldLayoutMkLst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3896841876" sldId="2147483649"/>
              <ac:spMk id="2" creationId="{77EC0D34-9CA3-2C63-36A5-15538AF076BB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3896841876" sldId="2147483649"/>
              <ac:spMk id="3" creationId="{46827F8F-AEE2-EC82-0358-1F48E1D33DD0}"/>
            </ac:spMkLst>
          </pc:spChg>
        </pc:sldLayoutChg>
        <pc:sldLayoutChg chg="modSp">
          <pc:chgData name="엄 경현" userId="006d52b91ace3e0e" providerId="LiveId" clId="{ABCF1FDA-C6D0-427D-8CEC-3529626B076C}" dt="2023-04-14T10:56:58.829" v="0"/>
          <pc:sldLayoutMkLst>
            <pc:docMk/>
            <pc:sldMasterMk cId="3484190589" sldId="2147483648"/>
            <pc:sldLayoutMk cId="4049303563" sldId="2147483651"/>
          </pc:sldLayoutMkLst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4049303563" sldId="2147483651"/>
              <ac:spMk id="2" creationId="{54064F66-2C27-9957-6865-89047BFD1492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4049303563" sldId="2147483651"/>
              <ac:spMk id="3" creationId="{77C4A32F-7B7F-DA19-D278-C71FB7D6A234}"/>
            </ac:spMkLst>
          </pc:spChg>
        </pc:sldLayoutChg>
        <pc:sldLayoutChg chg="modSp">
          <pc:chgData name="엄 경현" userId="006d52b91ace3e0e" providerId="LiveId" clId="{ABCF1FDA-C6D0-427D-8CEC-3529626B076C}" dt="2023-04-14T10:56:58.829" v="0"/>
          <pc:sldLayoutMkLst>
            <pc:docMk/>
            <pc:sldMasterMk cId="3484190589" sldId="2147483648"/>
            <pc:sldLayoutMk cId="363313043" sldId="2147483652"/>
          </pc:sldLayoutMkLst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363313043" sldId="2147483652"/>
              <ac:spMk id="3" creationId="{052BCF56-F22F-38F4-1CA3-8A1AD2CD8F91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363313043" sldId="2147483652"/>
              <ac:spMk id="4" creationId="{C7B2EEB0-7C70-55C4-6E3F-FB2608E46DD4}"/>
            </ac:spMkLst>
          </pc:spChg>
        </pc:sldLayoutChg>
        <pc:sldLayoutChg chg="modSp">
          <pc:chgData name="엄 경현" userId="006d52b91ace3e0e" providerId="LiveId" clId="{ABCF1FDA-C6D0-427D-8CEC-3529626B076C}" dt="2023-04-14T10:56:58.829" v="0"/>
          <pc:sldLayoutMkLst>
            <pc:docMk/>
            <pc:sldMasterMk cId="3484190589" sldId="2147483648"/>
            <pc:sldLayoutMk cId="1137412536" sldId="2147483653"/>
          </pc:sldLayoutMkLst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1137412536" sldId="2147483653"/>
              <ac:spMk id="2" creationId="{EB59BDEF-9062-735B-FD93-872858A9E77A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1137412536" sldId="2147483653"/>
              <ac:spMk id="3" creationId="{86E7D1F5-C5A0-31E9-DCD8-330BC68BCFF2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1137412536" sldId="2147483653"/>
              <ac:spMk id="4" creationId="{8EB627DF-A72F-1D19-4B93-59B26D370B95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1137412536" sldId="2147483653"/>
              <ac:spMk id="5" creationId="{DD390D6C-EF1A-E575-961F-9FC324FE2089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1137412536" sldId="2147483653"/>
              <ac:spMk id="6" creationId="{901DF93C-0157-1B32-EF19-B40D12AEA046}"/>
            </ac:spMkLst>
          </pc:spChg>
        </pc:sldLayoutChg>
        <pc:sldLayoutChg chg="modSp">
          <pc:chgData name="엄 경현" userId="006d52b91ace3e0e" providerId="LiveId" clId="{ABCF1FDA-C6D0-427D-8CEC-3529626B076C}" dt="2023-04-14T10:56:58.829" v="0"/>
          <pc:sldLayoutMkLst>
            <pc:docMk/>
            <pc:sldMasterMk cId="3484190589" sldId="2147483648"/>
            <pc:sldLayoutMk cId="3239006975" sldId="2147483656"/>
          </pc:sldLayoutMkLst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3239006975" sldId="2147483656"/>
              <ac:spMk id="2" creationId="{0419C8DE-7AA3-8979-58F2-6EFB4B3C2B9B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3239006975" sldId="2147483656"/>
              <ac:spMk id="3" creationId="{D070026F-2D8D-1E6D-5F7C-8EFC90AF3D24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3239006975" sldId="2147483656"/>
              <ac:spMk id="4" creationId="{77F9FDFF-34A4-45ED-C707-9B0F1C5231B0}"/>
            </ac:spMkLst>
          </pc:spChg>
        </pc:sldLayoutChg>
        <pc:sldLayoutChg chg="modSp">
          <pc:chgData name="엄 경현" userId="006d52b91ace3e0e" providerId="LiveId" clId="{ABCF1FDA-C6D0-427D-8CEC-3529626B076C}" dt="2023-04-14T10:56:58.829" v="0"/>
          <pc:sldLayoutMkLst>
            <pc:docMk/>
            <pc:sldMasterMk cId="3484190589" sldId="2147483648"/>
            <pc:sldLayoutMk cId="2331590197" sldId="2147483657"/>
          </pc:sldLayoutMkLst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2331590197" sldId="2147483657"/>
              <ac:spMk id="2" creationId="{CB6D0664-C825-0ED8-2339-F18DE90A71E9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2331590197" sldId="2147483657"/>
              <ac:spMk id="3" creationId="{6769934D-74DB-40E6-7690-D63DB57E9F3D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2331590197" sldId="2147483657"/>
              <ac:spMk id="4" creationId="{E2805C6A-FDF8-CF35-EBE3-2DDAE1B99E07}"/>
            </ac:spMkLst>
          </pc:spChg>
        </pc:sldLayoutChg>
        <pc:sldLayoutChg chg="modSp">
          <pc:chgData name="엄 경현" userId="006d52b91ace3e0e" providerId="LiveId" clId="{ABCF1FDA-C6D0-427D-8CEC-3529626B076C}" dt="2023-04-14T10:56:58.829" v="0"/>
          <pc:sldLayoutMkLst>
            <pc:docMk/>
            <pc:sldMasterMk cId="3484190589" sldId="2147483648"/>
            <pc:sldLayoutMk cId="225172192" sldId="2147483659"/>
          </pc:sldLayoutMkLst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225172192" sldId="2147483659"/>
              <ac:spMk id="2" creationId="{115AA9E2-C15C-F1B6-4284-B5191A799D32}"/>
            </ac:spMkLst>
          </pc:spChg>
          <pc:spChg chg="mod">
            <ac:chgData name="엄 경현" userId="006d52b91ace3e0e" providerId="LiveId" clId="{ABCF1FDA-C6D0-427D-8CEC-3529626B076C}" dt="2023-04-14T10:56:58.829" v="0"/>
            <ac:spMkLst>
              <pc:docMk/>
              <pc:sldMasterMk cId="3484190589" sldId="2147483648"/>
              <pc:sldLayoutMk cId="225172192" sldId="2147483659"/>
              <ac:spMk id="3" creationId="{E5AAE863-1779-F656-7AB6-73B3F5C6EC15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9833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0813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7845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3754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469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0719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3143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2300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1435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6423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783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F343A2-90B0-4DC4-BB67-BA5AFAF8C92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94046-166C-41DA-B621-94E274779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0810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62AA0466-0146-7995-F1F2-EAC82CED3E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3435124"/>
              </p:ext>
            </p:extLst>
          </p:nvPr>
        </p:nvGraphicFramePr>
        <p:xfrm>
          <a:off x="101234" y="723454"/>
          <a:ext cx="8941531" cy="573654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040484">
                  <a:extLst>
                    <a:ext uri="{9D8B030D-6E8A-4147-A177-3AD203B41FA5}">
                      <a16:colId xmlns:a16="http://schemas.microsoft.com/office/drawing/2014/main" val="3942615040"/>
                    </a:ext>
                  </a:extLst>
                </a:gridCol>
                <a:gridCol w="1040484">
                  <a:extLst>
                    <a:ext uri="{9D8B030D-6E8A-4147-A177-3AD203B41FA5}">
                      <a16:colId xmlns:a16="http://schemas.microsoft.com/office/drawing/2014/main" val="4169604473"/>
                    </a:ext>
                  </a:extLst>
                </a:gridCol>
                <a:gridCol w="756603">
                  <a:extLst>
                    <a:ext uri="{9D8B030D-6E8A-4147-A177-3AD203B41FA5}">
                      <a16:colId xmlns:a16="http://schemas.microsoft.com/office/drawing/2014/main" val="726831421"/>
                    </a:ext>
                  </a:extLst>
                </a:gridCol>
                <a:gridCol w="2947487">
                  <a:extLst>
                    <a:ext uri="{9D8B030D-6E8A-4147-A177-3AD203B41FA5}">
                      <a16:colId xmlns:a16="http://schemas.microsoft.com/office/drawing/2014/main" val="2561017744"/>
                    </a:ext>
                  </a:extLst>
                </a:gridCol>
                <a:gridCol w="3156473">
                  <a:extLst>
                    <a:ext uri="{9D8B030D-6E8A-4147-A177-3AD203B41FA5}">
                      <a16:colId xmlns:a16="http://schemas.microsoft.com/office/drawing/2014/main" val="14240572"/>
                    </a:ext>
                  </a:extLst>
                </a:gridCol>
              </a:tblGrid>
              <a:tr h="211844">
                <a:tc>
                  <a:txBody>
                    <a:bodyPr/>
                    <a:lstStyle/>
                    <a:p>
                      <a:pPr algn="ctr" rtl="0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Gen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Chromoso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F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R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8189108"/>
                  </a:ext>
                </a:extLst>
              </a:tr>
              <a:tr h="211844">
                <a:tc rowSpan="13"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</a:t>
                      </a:r>
                      <a:r>
                        <a:rPr lang="en-US" sz="12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st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 PCR</a:t>
                      </a:r>
                    </a:p>
                  </a:txBody>
                  <a:tcPr marL="45720" marR="4572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STN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2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CTTCCTCCAGACTGATTGG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GGCACCTTTGTCTGGCTTA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95900783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MSTN Off-target 1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CCATTCCATTATGCCAAAC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>
                          <a:effectLst/>
                          <a:latin typeface="+mn-lt"/>
                        </a:rPr>
                        <a:t>TGCTCAGTTGTGTCCGTCTC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2649556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MSTN Off-target 2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4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TGAGCCCCTACTTTGTGGA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GCACCCCTTACCAGAAAAC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3569134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MSTN Off-target 3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8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TGTTGGGCAGTACTGGTTG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>
                          <a:effectLst/>
                          <a:latin typeface="+mn-lt"/>
                        </a:rPr>
                        <a:t>GCCACAGTGTTTGAGAGTGC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24258627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>
                          <a:effectLst/>
                          <a:latin typeface="+mn-lt"/>
                        </a:rPr>
                        <a:t>MSTN Off-target 4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9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TCCTTGCACCTTCCAAAAT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CCCTGAAGGCTGGAGTTAC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6635140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MSTN Off-target 5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>
                          <a:effectLst/>
                          <a:latin typeface="+mn-lt"/>
                        </a:rPr>
                        <a:t>2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TGACCATGATGGCTACTCC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ATGTGGTCCACTGGAGAAG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24031015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PRNP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3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ATGGGCATATGATGCTGAC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ACAGGAAGGTTGCCCCTAT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03588437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PRNP Off-target 1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3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TGAGTGTTTGCATTCTGGAAA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CCATGTGTGTGGATATCTGTT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86380362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PRNP Off-target 2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AGTGATAGCCAGGTCACAC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GCCCTGGTCTCTGTGGTTA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801228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PRNP Off-target 3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7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TGCAAAAAGCCAACTCATT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GGCTTTGTTCTCAGGTGGA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89586648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PRNP Off-target 4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19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TAAGATCCCACAAGCCAAG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TGGAGAGGGTATGGGAAAC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88327174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PRNP Off-target 5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24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GTAATGGAAACTGGGCAAG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TCTGTTGCATGTCTCACAGAA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83329469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BLG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1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TCAGACGGGGGTCAGAGT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CCACCTCGAAGCTTTCTCAT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14245544"/>
                  </a:ext>
                </a:extLst>
              </a:tr>
              <a:tr h="211844">
                <a:tc rowSpan="13"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2</a:t>
                      </a:r>
                      <a:r>
                        <a:rPr lang="en-US" altLang="ko-KR" sz="12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nd</a:t>
                      </a:r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+mn-ea"/>
                        </a:rPr>
                        <a:t> PCR</a:t>
                      </a:r>
                    </a:p>
                  </a:txBody>
                  <a:tcPr marL="45720" marR="4572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MSTN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2</a:t>
                      </a: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TGGAAGGAAAACCCAAATGT</a:t>
                      </a: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CCTGGGTTCATGTCAAGTTTC</a:t>
                      </a: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71257467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MSTN Off-target 1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2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CTCAGCACTCCAGAGTCCAA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CCCCATGAGTCTGATAATAGGC</a:t>
                      </a: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98726036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MSTN Off-target 2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4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TCCACCCTGGAGATTCTGAC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GCTAGGAATGTTGAGGCGTTA</a:t>
                      </a: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298654294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MSTN Off-target 3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8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TGTGTGTGAGTTCTCAAGTGTAAAA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GCCAAGAGAAAAAGAGAGAGAAA</a:t>
                      </a: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1142778188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>
                          <a:effectLst/>
                          <a:latin typeface="+mn-lt"/>
                        </a:rPr>
                        <a:t>MSTN Off-target 4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9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GGGCTCCTATCCCTTTACCA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ACGGGAAGAGGTCTCCGTAA</a:t>
                      </a: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1514531940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>
                          <a:effectLst/>
                          <a:latin typeface="+mn-lt"/>
                        </a:rPr>
                        <a:t>MSTN Off-target 5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>
                          <a:effectLst/>
                          <a:latin typeface="+mn-lt"/>
                        </a:rPr>
                        <a:t>20</a:t>
                      </a:r>
                      <a:endParaRPr lang="en-US" altLang="ko-KR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CACTTCCAATTTGCCCTGAT</a:t>
                      </a:r>
                    </a:p>
                  </a:txBody>
                  <a:tcPr marL="45720" marR="457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TGAAAGAGGAACTCCCAAGG</a:t>
                      </a:r>
                    </a:p>
                  </a:txBody>
                  <a:tcPr marL="45720" marR="457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9442704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PRNP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3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GCAACCGTTATCCACCTCAG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CCAGCATGTAGCCACCAAG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57983357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PRNP Off-target 1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3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CATGTTTAAGCTCAGAAATATGGA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TTTCATTAATTTGGAGTGATTCTCTT</a:t>
                      </a: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2717542841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PRNP Off-target 2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5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CAGCCCCCTCATAAGTGTGT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CCCTCCAAAGCCTTGTTCTT</a:t>
                      </a: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3740187406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>
                          <a:effectLst/>
                          <a:latin typeface="+mn-lt"/>
                        </a:rPr>
                        <a:t>PRNP Off-target 3</a:t>
                      </a:r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7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GGAGATGGTGAAGGACAGGA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GGGGTGTTGCTCCCTAGAAT</a:t>
                      </a: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640401590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PRNP Off-target 4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19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CCAGAGAAAAGCCATGCAAT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AGTCAATGGCAACTGGAAGG</a:t>
                      </a: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4258724729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u="none" strike="noStrike" dirty="0">
                          <a:effectLst/>
                          <a:latin typeface="+mn-lt"/>
                        </a:rPr>
                        <a:t>PRNP Off-target 5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u="none" strike="noStrike" dirty="0">
                          <a:effectLst/>
                          <a:latin typeface="+mn-lt"/>
                        </a:rPr>
                        <a:t>24</a:t>
                      </a:r>
                      <a:endParaRPr lang="en-US" altLang="ko-KR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GGCTGTTTTGATATGGGTCA</a:t>
                      </a:r>
                    </a:p>
                  </a:txBody>
                  <a:tcPr marL="45720" marR="457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GGACAGCTAAAGGCTGTGGA</a:t>
                      </a:r>
                    </a:p>
                  </a:txBody>
                  <a:tcPr marL="45720" marR="4572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8095546"/>
                  </a:ext>
                </a:extLst>
              </a:tr>
              <a:tr h="211844">
                <a:tc vMerge="1">
                  <a:txBody>
                    <a:bodyPr/>
                    <a:lstStyle/>
                    <a:p>
                      <a:pPr algn="ctr" rtl="0" fontAlgn="ctr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맑은 고딕" panose="020B0503020000020004" pitchFamily="50" charset="-127"/>
                      </a:endParaRP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BLG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11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ACACTCTTTCCCTACACGAC GCTCTTCCGATCT GCTGTCTTTCAGGGAGAACG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맑은 고딕" panose="020B0503020000020004" pitchFamily="50" charset="-127"/>
                        </a:rPr>
                        <a:t>GTGACTGGAGTTCAGACGTGT GCTCTTCCGATCT CACGGCAGTGTCTTCATCAC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697828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2859C1B-85F2-6FB3-D888-8851A7C9DEB5}"/>
              </a:ext>
            </a:extLst>
          </p:cNvPr>
          <p:cNvSpPr txBox="1"/>
          <p:nvPr/>
        </p:nvSpPr>
        <p:spPr>
          <a:xfrm>
            <a:off x="0" y="90225"/>
            <a:ext cx="85350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Supplementary Table 2. List of primer sequences for deep sequencing of each target genes and off-target sites</a:t>
            </a:r>
            <a:endParaRPr lang="en-US" altLang="ko-KR" sz="1400" dirty="0"/>
          </a:p>
        </p:txBody>
      </p:sp>
    </p:spTree>
    <p:extLst>
      <p:ext uri="{BB962C8B-B14F-4D97-AF65-F5344CB8AC3E}">
        <p14:creationId xmlns:p14="http://schemas.microsoft.com/office/powerpoint/2010/main" val="3600864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222</Words>
  <Application>Microsoft Office PowerPoint</Application>
  <PresentationFormat>화면 슬라이드 쇼(4:3)</PresentationFormat>
  <Paragraphs>11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엄 경현</dc:creator>
  <cp:lastModifiedBy>엄 경현</cp:lastModifiedBy>
  <cp:revision>1</cp:revision>
  <dcterms:created xsi:type="dcterms:W3CDTF">2023-04-14T10:55:29Z</dcterms:created>
  <dcterms:modified xsi:type="dcterms:W3CDTF">2023-04-14T10:57:11Z</dcterms:modified>
</cp:coreProperties>
</file>